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81" r:id="rId2"/>
    <p:sldId id="280" r:id="rId3"/>
  </p:sldIdLst>
  <p:sldSz cx="6858000" cy="9144000" type="screen4x3"/>
  <p:notesSz cx="6797675" cy="9928225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Usuario" initials="U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  <a:srgbClr val="CC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18E52A-DCE7-8340-8413-A2CDA0F5CBDF}" v="1" dt="2022-08-23T17:35:40.570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Estilo claro 1 - Acento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5082" autoAdjust="0"/>
  </p:normalViewPr>
  <p:slideViewPr>
    <p:cSldViewPr>
      <p:cViewPr varScale="1">
        <p:scale>
          <a:sx n="79" d="100"/>
          <a:sy n="79" d="100"/>
        </p:scale>
        <p:origin x="3064" y="21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commentAuthors" Target="commentAuthors.xml"/><Relationship Id="rId10" Type="http://schemas.microsoft.com/office/2016/11/relationships/changesInfo" Target="changesInfos/changesInfo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aria Luisa Cayuela Fuentes" userId="04f8a162-1285-4898-8e06-f40448777be7" providerId="ADAL" clId="{3D18E52A-DCE7-8340-8413-A2CDA0F5CBDF}"/>
    <pc:docChg chg="custSel modSld">
      <pc:chgData name="Maria Luisa Cayuela Fuentes" userId="04f8a162-1285-4898-8e06-f40448777be7" providerId="ADAL" clId="{3D18E52A-DCE7-8340-8413-A2CDA0F5CBDF}" dt="2022-08-23T17:35:40.570" v="1"/>
      <pc:docMkLst>
        <pc:docMk/>
      </pc:docMkLst>
      <pc:sldChg chg="addSp delSp modSp mod">
        <pc:chgData name="Maria Luisa Cayuela Fuentes" userId="04f8a162-1285-4898-8e06-f40448777be7" providerId="ADAL" clId="{3D18E52A-DCE7-8340-8413-A2CDA0F5CBDF}" dt="2022-08-23T17:35:40.570" v="1"/>
        <pc:sldMkLst>
          <pc:docMk/>
          <pc:sldMk cId="1098883779" sldId="280"/>
        </pc:sldMkLst>
        <pc:graphicFrameChg chg="add mod">
          <ac:chgData name="Maria Luisa Cayuela Fuentes" userId="04f8a162-1285-4898-8e06-f40448777be7" providerId="ADAL" clId="{3D18E52A-DCE7-8340-8413-A2CDA0F5CBDF}" dt="2022-08-23T17:35:40.570" v="1"/>
          <ac:graphicFrameMkLst>
            <pc:docMk/>
            <pc:sldMk cId="1098883779" sldId="280"/>
            <ac:graphicFrameMk id="2" creationId="{6DB39D59-A3D0-AD09-BC48-CE4768D89438}"/>
          </ac:graphicFrameMkLst>
        </pc:graphicFrameChg>
        <pc:graphicFrameChg chg="del">
          <ac:chgData name="Maria Luisa Cayuela Fuentes" userId="04f8a162-1285-4898-8e06-f40448777be7" providerId="ADAL" clId="{3D18E52A-DCE7-8340-8413-A2CDA0F5CBDF}" dt="2022-08-23T17:35:14.468" v="0" actId="478"/>
          <ac:graphicFrameMkLst>
            <pc:docMk/>
            <pc:sldMk cId="1098883779" sldId="280"/>
            <ac:graphicFrameMk id="5" creationId="{CB93D765-96F2-4206-BCB9-D6F23A8A381F}"/>
          </ac:graphicFrameMkLst>
        </pc:graphicFrame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9E4DADB-9210-46F7-93ED-FD0605B7F8F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AE5354-30B4-47F1-BDE6-7F1094049A08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007642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47CFC-816F-41D0-AAC0-9BF4FEBC753E}" type="datetimeFigureOut">
              <a:rPr lang="es-ES" smtClean="0"/>
              <a:t>23/8/22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2FADFE-3B8F-471C-ABF0-DBC7717ECBBC}" type="slidenum">
              <a:rPr lang="es-ES" smtClean="0"/>
              <a:t>‹Nº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CuadroTexto"/>
          <p:cNvSpPr txBox="1"/>
          <p:nvPr/>
        </p:nvSpPr>
        <p:spPr>
          <a:xfrm>
            <a:off x="0" y="-1463"/>
            <a:ext cx="9684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</a:t>
            </a:r>
          </a:p>
        </p:txBody>
      </p:sp>
      <p:sp>
        <p:nvSpPr>
          <p:cNvPr id="5" name="4 CuadroTexto"/>
          <p:cNvSpPr txBox="1"/>
          <p:nvPr/>
        </p:nvSpPr>
        <p:spPr>
          <a:xfrm>
            <a:off x="141350" y="3563888"/>
            <a:ext cx="65808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s-E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ular senescence levels in Spint1a-deficient larvae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Representative images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h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ellular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nescenc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evels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y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A</a:t>
            </a:r>
            <a:r>
              <a:rPr lang="en-US" sz="1200" dirty="0">
                <a:latin typeface="Symbol" panose="05050102010706020507" pitchFamily="18" charset="2"/>
                <a:cs typeface="Times New Roman" panose="02020603050405020304" pitchFamily="18" charset="0"/>
              </a:rPr>
              <a:t> 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gal staining assay 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3-dpf Spint1a-deficient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rva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mpared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o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wild </a:t>
            </a:r>
            <a:r>
              <a:rPr lang="es-E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type</a:t>
            </a:r>
            <a:r>
              <a:rPr lang="es-E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s-E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174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2656" y="1115616"/>
            <a:ext cx="4067175" cy="20177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76931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2 Rectángulo"/>
          <p:cNvSpPr/>
          <p:nvPr/>
        </p:nvSpPr>
        <p:spPr>
          <a:xfrm>
            <a:off x="260648" y="395536"/>
            <a:ext cx="648072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>
                <a:latin typeface="Times New Roman" panose="02020603050405020304" pitchFamily="18" charset="0"/>
                <a:cs typeface="Times New Roman" panose="02020603050405020304" pitchFamily="18" charset="0"/>
              </a:rPr>
              <a:t>Table S1: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ene accession numbers and primer sequences used for gene expression analysis.</a:t>
            </a:r>
            <a:endParaRPr lang="es-E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6DB39D59-A3D0-AD09-BC48-CE4768D8943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0908268"/>
              </p:ext>
            </p:extLst>
          </p:nvPr>
        </p:nvGraphicFramePr>
        <p:xfrm>
          <a:off x="404664" y="971600"/>
          <a:ext cx="6120680" cy="3581403"/>
        </p:xfrm>
        <a:graphic>
          <a:graphicData uri="http://schemas.openxmlformats.org/drawingml/2006/table">
            <a:tbl>
              <a:tblPr firstRow="1" firstCol="1" bandRow="1">
                <a:tableStyleId>{3B4B98B0-60AC-42C2-AFA5-B58CD77FA1E5}</a:tableStyleId>
              </a:tblPr>
              <a:tblGrid>
                <a:gridCol w="544349">
                  <a:extLst>
                    <a:ext uri="{9D8B030D-6E8A-4147-A177-3AD203B41FA5}">
                      <a16:colId xmlns:a16="http://schemas.microsoft.com/office/drawing/2014/main" val="232072367"/>
                    </a:ext>
                  </a:extLst>
                </a:gridCol>
                <a:gridCol w="111183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76064">
                  <a:extLst>
                    <a:ext uri="{9D8B030D-6E8A-4147-A177-3AD203B41FA5}">
                      <a16:colId xmlns:a16="http://schemas.microsoft.com/office/drawing/2014/main" val="1534559014"/>
                    </a:ext>
                  </a:extLst>
                </a:gridCol>
                <a:gridCol w="1800200">
                  <a:extLst>
                    <a:ext uri="{9D8B030D-6E8A-4147-A177-3AD203B41FA5}">
                      <a16:colId xmlns:a16="http://schemas.microsoft.com/office/drawing/2014/main" val="3054350806"/>
                    </a:ext>
                  </a:extLst>
                </a:gridCol>
                <a:gridCol w="208823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218247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 </a:t>
                      </a:r>
                      <a:r>
                        <a:rPr lang="es-ES" sz="1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me</a:t>
                      </a:r>
                      <a:endParaRPr lang="es-ES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Bank</a:t>
                      </a:r>
                      <a:r>
                        <a:rPr lang="es-E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ccesion</a:t>
                      </a:r>
                      <a:r>
                        <a:rPr lang="es-ES" sz="10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10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umber</a:t>
                      </a:r>
                      <a:endParaRPr lang="es-ES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 name </a:t>
                      </a:r>
                      <a:endParaRPr lang="es-ES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1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r>
                        <a:rPr lang="es-E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5’ </a:t>
                      </a:r>
                      <a:r>
                        <a:rPr lang="es-ES" sz="10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  <a:sym typeface="Wingdings" panose="05000000000000000000" pitchFamily="2" charset="2"/>
                        </a:rPr>
                        <a:t> 3’)</a:t>
                      </a:r>
                      <a:endParaRPr lang="es-ES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10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plication</a:t>
                      </a:r>
                      <a:endParaRPr lang="es-ES" sz="10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2132841"/>
                  </a:ext>
                </a:extLst>
              </a:tr>
              <a:tr h="436494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b="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l1b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212844.2</a:t>
                      </a:r>
                      <a:endParaRPr lang="es-ES" sz="900" b="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TGTGTGTTTGGGAATCT 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GATAAACCAACCGGGACA 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e </a:t>
                      </a: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436494">
                <a:tc>
                  <a:txBody>
                    <a:bodyPr/>
                    <a:lstStyle/>
                    <a:p>
                      <a:pPr algn="ctr"/>
                      <a:r>
                        <a:rPr lang="es-ES" sz="900" b="0" i="1" kern="1200" dirty="0" err="1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nf</a:t>
                      </a:r>
                      <a:r>
                        <a:rPr lang="es-ES" sz="9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</a:t>
                      </a:r>
                      <a:r>
                        <a:rPr lang="es-ES" sz="9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  <a:sym typeface="Symbol" pitchFamily="2" charset="2"/>
                        </a:rPr>
                        <a:t></a:t>
                      </a:r>
                      <a:endParaRPr lang="es-ES" sz="9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024447.1</a:t>
                      </a:r>
                      <a:endParaRPr lang="es-ES" sz="900" b="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CGCTTTTCTGAATCCTACG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GCCCAGTCTGTCTCCTTCT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e </a:t>
                      </a: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3415360495"/>
                  </a:ext>
                </a:extLst>
              </a:tr>
              <a:tr h="436494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="0" i="1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xcl8.b</a:t>
                      </a:r>
                      <a:endParaRPr lang="es-ES" sz="9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  <a:p>
                      <a:pPr algn="ctr"/>
                      <a:endParaRPr lang="es-ES" sz="900" b="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b="0" i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M_001327985.1</a:t>
                      </a:r>
                      <a:endParaRPr lang="es-ES" sz="900" b="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CTGGATCACACTGCAGAAA</a:t>
                      </a: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TGCTGCAAACTTTTCCTTGA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ene </a:t>
                      </a:r>
                      <a:r>
                        <a:rPr lang="es-ES" sz="900" dirty="0" err="1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969146014"/>
                  </a:ext>
                </a:extLst>
              </a:tr>
              <a:tr h="436494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n-GB" sz="9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ps11  </a:t>
                      </a:r>
                      <a:endParaRPr lang="es-ES" sz="900" b="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b="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M_213377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AGAAATGCCCCTTCACTG 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CCTCTTCTCAAGGTTG 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r>
                        <a:rPr lang="es-ES" sz="9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ression</a:t>
                      </a:r>
                      <a:r>
                        <a:rPr lang="es-ES" sz="9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&amp;  </a:t>
                      </a:r>
                      <a:r>
                        <a:rPr lang="es-ES" sz="9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lomere</a:t>
                      </a:r>
                      <a:r>
                        <a:rPr lang="es-ES" sz="9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996555288"/>
                  </a:ext>
                </a:extLst>
              </a:tr>
              <a:tr h="436494"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n-GB" sz="900" b="0" i="1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lom</a:t>
                      </a:r>
                      <a:r>
                        <a:rPr lang="en-GB" sz="900" b="0" i="1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s-ES" sz="900" b="0" i="1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b="0" i="1" dirty="0"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---</a:t>
                      </a: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algn="ctr">
                        <a:lnSpc>
                          <a:spcPts val="1700"/>
                        </a:lnSpc>
                        <a:spcAft>
                          <a:spcPts val="800"/>
                        </a:spcAft>
                      </a:pPr>
                      <a:r>
                        <a:rPr lang="es-ES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GTTTTTGAGGGTGAGGGTGAGGGTGAGGGTGAGGGT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9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CCCGAACTATCCCTATCCCTATCCCTATCCCTATCCCTA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ts val="17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s-ES" sz="9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elomere</a:t>
                      </a:r>
                      <a:r>
                        <a:rPr lang="es-ES" sz="9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s-ES" sz="900" baseline="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ngth</a:t>
                      </a:r>
                      <a:endParaRPr lang="es-ES" sz="9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09888377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icin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icin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icin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922</TotalTime>
  <Words>120</Words>
  <Application>Microsoft Macintosh PowerPoint</Application>
  <PresentationFormat>Presentación en pantalla (4:3)</PresentationFormat>
  <Paragraphs>43</Paragraphs>
  <Slides>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2</vt:i4>
      </vt:variant>
    </vt:vector>
  </HeadingPairs>
  <TitlesOfParts>
    <vt:vector size="7" baseType="lpstr">
      <vt:lpstr>Arial</vt:lpstr>
      <vt:lpstr>Calibri</vt:lpstr>
      <vt:lpstr>Symbol</vt:lpstr>
      <vt:lpstr>Times New Roman</vt:lpstr>
      <vt:lpstr>Tema de Office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Usuario</dc:creator>
  <cp:lastModifiedBy>Maria Luisa Cayuela Fuentes</cp:lastModifiedBy>
  <cp:revision>211</cp:revision>
  <cp:lastPrinted>2022-05-09T07:33:16Z</cp:lastPrinted>
  <dcterms:created xsi:type="dcterms:W3CDTF">2022-03-15T11:31:50Z</dcterms:created>
  <dcterms:modified xsi:type="dcterms:W3CDTF">2022-08-23T17:35:50Z</dcterms:modified>
</cp:coreProperties>
</file>